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6200438" cy="208803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466" y="-5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3417232"/>
            <a:ext cx="13770372" cy="7269468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10967039"/>
            <a:ext cx="12150329" cy="5041259"/>
          </a:xfrm>
        </p:spPr>
        <p:txBody>
          <a:bodyPr/>
          <a:lstStyle>
            <a:lvl1pPr marL="0" indent="0" algn="ctr">
              <a:buNone/>
              <a:defRPr sz="4250"/>
            </a:lvl1pPr>
            <a:lvl2pPr marL="810260" indent="0" algn="ctr">
              <a:buNone/>
              <a:defRPr sz="3545"/>
            </a:lvl2pPr>
            <a:lvl3pPr marL="1619885" indent="0" algn="ctr">
              <a:buNone/>
              <a:defRPr sz="3190"/>
            </a:lvl3pPr>
            <a:lvl4pPr marL="2430145" indent="0" algn="ctr">
              <a:buNone/>
              <a:defRPr sz="2835"/>
            </a:lvl4pPr>
            <a:lvl5pPr marL="3239770" indent="0" algn="ctr">
              <a:buNone/>
              <a:defRPr sz="2835"/>
            </a:lvl5pPr>
            <a:lvl6pPr marL="4050030" indent="0" algn="ctr">
              <a:buNone/>
              <a:defRPr sz="2835"/>
            </a:lvl6pPr>
            <a:lvl7pPr marL="4860290" indent="0" algn="ctr">
              <a:buNone/>
              <a:defRPr sz="2835"/>
            </a:lvl7pPr>
            <a:lvl8pPr marL="5669915" indent="0" algn="ctr">
              <a:buNone/>
              <a:defRPr sz="2835"/>
            </a:lvl8pPr>
            <a:lvl9pPr marL="6480175" indent="0" algn="ctr">
              <a:buNone/>
              <a:defRPr sz="283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1111687"/>
            <a:ext cx="3493219" cy="1769516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1111687"/>
            <a:ext cx="10277153" cy="1769516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5205603"/>
            <a:ext cx="13972878" cy="8685660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13973433"/>
            <a:ext cx="13972878" cy="4567583"/>
          </a:xfrm>
        </p:spPr>
        <p:txBody>
          <a:bodyPr/>
          <a:lstStyle>
            <a:lvl1pPr marL="0" indent="0">
              <a:buNone/>
              <a:defRPr sz="4250">
                <a:solidFill>
                  <a:schemeClr val="tx1">
                    <a:tint val="82000"/>
                  </a:schemeClr>
                </a:solidFill>
              </a:defRPr>
            </a:lvl1pPr>
            <a:lvl2pPr marL="810260" indent="0">
              <a:buNone/>
              <a:defRPr sz="3545">
                <a:solidFill>
                  <a:schemeClr val="tx1">
                    <a:tint val="82000"/>
                  </a:schemeClr>
                </a:solidFill>
              </a:defRPr>
            </a:lvl2pPr>
            <a:lvl3pPr marL="1619885" indent="0">
              <a:buNone/>
              <a:defRPr sz="3190">
                <a:solidFill>
                  <a:schemeClr val="tx1">
                    <a:tint val="82000"/>
                  </a:schemeClr>
                </a:solidFill>
              </a:defRPr>
            </a:lvl3pPr>
            <a:lvl4pPr marL="2430145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4pPr>
            <a:lvl5pPr marL="3239770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5pPr>
            <a:lvl6pPr marL="4050030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6pPr>
            <a:lvl7pPr marL="4860290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7pPr>
            <a:lvl8pPr marL="5669915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8pPr>
            <a:lvl9pPr marL="6480175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5558437"/>
            <a:ext cx="6885186" cy="1324841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5558437"/>
            <a:ext cx="6885186" cy="1324841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111692"/>
            <a:ext cx="13972878" cy="403591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5118597"/>
            <a:ext cx="6853544" cy="2508545"/>
          </a:xfrm>
        </p:spPr>
        <p:txBody>
          <a:bodyPr anchor="b"/>
          <a:lstStyle>
            <a:lvl1pPr marL="0" indent="0">
              <a:buNone/>
              <a:defRPr sz="4250" b="1"/>
            </a:lvl1pPr>
            <a:lvl2pPr marL="810260" indent="0">
              <a:buNone/>
              <a:defRPr sz="3545" b="1"/>
            </a:lvl2pPr>
            <a:lvl3pPr marL="1619885" indent="0">
              <a:buNone/>
              <a:defRPr sz="3190" b="1"/>
            </a:lvl3pPr>
            <a:lvl4pPr marL="2430145" indent="0">
              <a:buNone/>
              <a:defRPr sz="2835" b="1"/>
            </a:lvl4pPr>
            <a:lvl5pPr marL="3239770" indent="0">
              <a:buNone/>
              <a:defRPr sz="2835" b="1"/>
            </a:lvl5pPr>
            <a:lvl6pPr marL="4050030" indent="0">
              <a:buNone/>
              <a:defRPr sz="2835" b="1"/>
            </a:lvl6pPr>
            <a:lvl7pPr marL="4860290" indent="0">
              <a:buNone/>
              <a:defRPr sz="2835" b="1"/>
            </a:lvl7pPr>
            <a:lvl8pPr marL="5669915" indent="0">
              <a:buNone/>
              <a:defRPr sz="2835" b="1"/>
            </a:lvl8pPr>
            <a:lvl9pPr marL="6480175" indent="0">
              <a:buNone/>
              <a:defRPr sz="283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7627142"/>
            <a:ext cx="6853544" cy="1121837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5118597"/>
            <a:ext cx="6887296" cy="2508545"/>
          </a:xfrm>
        </p:spPr>
        <p:txBody>
          <a:bodyPr anchor="b"/>
          <a:lstStyle>
            <a:lvl1pPr marL="0" indent="0">
              <a:buNone/>
              <a:defRPr sz="4250" b="1"/>
            </a:lvl1pPr>
            <a:lvl2pPr marL="810260" indent="0">
              <a:buNone/>
              <a:defRPr sz="3545" b="1"/>
            </a:lvl2pPr>
            <a:lvl3pPr marL="1619885" indent="0">
              <a:buNone/>
              <a:defRPr sz="3190" b="1"/>
            </a:lvl3pPr>
            <a:lvl4pPr marL="2430145" indent="0">
              <a:buNone/>
              <a:defRPr sz="2835" b="1"/>
            </a:lvl4pPr>
            <a:lvl5pPr marL="3239770" indent="0">
              <a:buNone/>
              <a:defRPr sz="2835" b="1"/>
            </a:lvl5pPr>
            <a:lvl6pPr marL="4050030" indent="0">
              <a:buNone/>
              <a:defRPr sz="2835" b="1"/>
            </a:lvl6pPr>
            <a:lvl7pPr marL="4860290" indent="0">
              <a:buNone/>
              <a:defRPr sz="2835" b="1"/>
            </a:lvl7pPr>
            <a:lvl8pPr marL="5669915" indent="0">
              <a:buNone/>
              <a:defRPr sz="2835" b="1"/>
            </a:lvl8pPr>
            <a:lvl9pPr marL="6480175" indent="0">
              <a:buNone/>
              <a:defRPr sz="283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7627142"/>
            <a:ext cx="6887296" cy="1121837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392026"/>
            <a:ext cx="5225063" cy="4872091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3006394"/>
            <a:ext cx="8201472" cy="14838609"/>
          </a:xfrm>
        </p:spPr>
        <p:txBody>
          <a:bodyPr/>
          <a:lstStyle>
            <a:lvl1pPr>
              <a:defRPr sz="5670"/>
            </a:lvl1pPr>
            <a:lvl2pPr>
              <a:defRPr sz="4960"/>
            </a:lvl2pPr>
            <a:lvl3pPr>
              <a:defRPr sz="4250"/>
            </a:lvl3pPr>
            <a:lvl4pPr>
              <a:defRPr sz="3545"/>
            </a:lvl4pPr>
            <a:lvl5pPr>
              <a:defRPr sz="3545"/>
            </a:lvl5pPr>
            <a:lvl6pPr>
              <a:defRPr sz="3545"/>
            </a:lvl6pPr>
            <a:lvl7pPr>
              <a:defRPr sz="3545"/>
            </a:lvl7pPr>
            <a:lvl8pPr>
              <a:defRPr sz="3545"/>
            </a:lvl8pPr>
            <a:lvl9pPr>
              <a:defRPr sz="354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6264116"/>
            <a:ext cx="5225063" cy="11605051"/>
          </a:xfrm>
        </p:spPr>
        <p:txBody>
          <a:bodyPr/>
          <a:lstStyle>
            <a:lvl1pPr marL="0" indent="0">
              <a:buNone/>
              <a:defRPr sz="2835"/>
            </a:lvl1pPr>
            <a:lvl2pPr marL="810260" indent="0">
              <a:buNone/>
              <a:defRPr sz="2480"/>
            </a:lvl2pPr>
            <a:lvl3pPr marL="1619885" indent="0">
              <a:buNone/>
              <a:defRPr sz="2125"/>
            </a:lvl3pPr>
            <a:lvl4pPr marL="2430145" indent="0">
              <a:buNone/>
              <a:defRPr sz="1770"/>
            </a:lvl4pPr>
            <a:lvl5pPr marL="3239770" indent="0">
              <a:buNone/>
              <a:defRPr sz="1770"/>
            </a:lvl5pPr>
            <a:lvl6pPr marL="4050030" indent="0">
              <a:buNone/>
              <a:defRPr sz="1770"/>
            </a:lvl6pPr>
            <a:lvl7pPr marL="4860290" indent="0">
              <a:buNone/>
              <a:defRPr sz="1770"/>
            </a:lvl7pPr>
            <a:lvl8pPr marL="5669915" indent="0">
              <a:buNone/>
              <a:defRPr sz="1770"/>
            </a:lvl8pPr>
            <a:lvl9pPr marL="6480175" indent="0">
              <a:buNone/>
              <a:defRPr sz="177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392026"/>
            <a:ext cx="5225063" cy="4872091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3006394"/>
            <a:ext cx="8201472" cy="14838609"/>
          </a:xfrm>
        </p:spPr>
        <p:txBody>
          <a:bodyPr anchor="t"/>
          <a:lstStyle>
            <a:lvl1pPr marL="0" indent="0">
              <a:buNone/>
              <a:defRPr sz="5670"/>
            </a:lvl1pPr>
            <a:lvl2pPr marL="810260" indent="0">
              <a:buNone/>
              <a:defRPr sz="4960"/>
            </a:lvl2pPr>
            <a:lvl3pPr marL="1619885" indent="0">
              <a:buNone/>
              <a:defRPr sz="4250"/>
            </a:lvl3pPr>
            <a:lvl4pPr marL="2430145" indent="0">
              <a:buNone/>
              <a:defRPr sz="3545"/>
            </a:lvl4pPr>
            <a:lvl5pPr marL="3239770" indent="0">
              <a:buNone/>
              <a:defRPr sz="3545"/>
            </a:lvl5pPr>
            <a:lvl6pPr marL="4050030" indent="0">
              <a:buNone/>
              <a:defRPr sz="3545"/>
            </a:lvl6pPr>
            <a:lvl7pPr marL="4860290" indent="0">
              <a:buNone/>
              <a:defRPr sz="3545"/>
            </a:lvl7pPr>
            <a:lvl8pPr marL="5669915" indent="0">
              <a:buNone/>
              <a:defRPr sz="3545"/>
            </a:lvl8pPr>
            <a:lvl9pPr marL="6480175" indent="0">
              <a:buNone/>
              <a:defRPr sz="354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6264116"/>
            <a:ext cx="5225063" cy="11605051"/>
          </a:xfrm>
        </p:spPr>
        <p:txBody>
          <a:bodyPr/>
          <a:lstStyle>
            <a:lvl1pPr marL="0" indent="0">
              <a:buNone/>
              <a:defRPr sz="2835"/>
            </a:lvl1pPr>
            <a:lvl2pPr marL="810260" indent="0">
              <a:buNone/>
              <a:defRPr sz="2480"/>
            </a:lvl2pPr>
            <a:lvl3pPr marL="1619885" indent="0">
              <a:buNone/>
              <a:defRPr sz="2125"/>
            </a:lvl3pPr>
            <a:lvl4pPr marL="2430145" indent="0">
              <a:buNone/>
              <a:defRPr sz="1770"/>
            </a:lvl4pPr>
            <a:lvl5pPr marL="3239770" indent="0">
              <a:buNone/>
              <a:defRPr sz="1770"/>
            </a:lvl5pPr>
            <a:lvl6pPr marL="4050030" indent="0">
              <a:buNone/>
              <a:defRPr sz="1770"/>
            </a:lvl6pPr>
            <a:lvl7pPr marL="4860290" indent="0">
              <a:buNone/>
              <a:defRPr sz="1770"/>
            </a:lvl7pPr>
            <a:lvl8pPr marL="5669915" indent="0">
              <a:buNone/>
              <a:defRPr sz="1770"/>
            </a:lvl8pPr>
            <a:lvl9pPr marL="6480175" indent="0">
              <a:buNone/>
              <a:defRPr sz="177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1111692"/>
            <a:ext cx="13972878" cy="4035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5558437"/>
            <a:ext cx="13972878" cy="132484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19353031"/>
            <a:ext cx="3645099" cy="11116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D0BFB6-D88D-43AF-8A30-15A1F9FF4248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19353031"/>
            <a:ext cx="5467648" cy="11116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19353031"/>
            <a:ext cx="3645099" cy="11116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1C8D87-B450-4372-9BAF-8256999B5FD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619885" rtl="0" eaLnBrk="1" latinLnBrk="0" hangingPunct="1">
        <a:lnSpc>
          <a:spcPct val="90000"/>
        </a:lnSpc>
        <a:spcBef>
          <a:spcPct val="0"/>
        </a:spcBef>
        <a:buNone/>
        <a:defRPr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130" indent="-405130" algn="l" defTabSz="1619885" rtl="0" eaLnBrk="1" latinLnBrk="0" hangingPunct="1">
        <a:lnSpc>
          <a:spcPct val="90000"/>
        </a:lnSpc>
        <a:spcBef>
          <a:spcPts val="1770"/>
        </a:spcBef>
        <a:buFont typeface="Arial" panose="020B0604020202020204" pitchFamily="34" charset="0"/>
        <a:buChar char="•"/>
        <a:defRPr sz="4960" kern="1200">
          <a:solidFill>
            <a:schemeClr val="tx1"/>
          </a:solidFill>
          <a:latin typeface="+mn-lt"/>
          <a:ea typeface="+mn-ea"/>
          <a:cs typeface="+mn-cs"/>
        </a:defRPr>
      </a:lvl1pPr>
      <a:lvl2pPr marL="1214755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4250" kern="1200">
          <a:solidFill>
            <a:schemeClr val="tx1"/>
          </a:solidFill>
          <a:latin typeface="+mn-lt"/>
          <a:ea typeface="+mn-ea"/>
          <a:cs typeface="+mn-cs"/>
        </a:defRPr>
      </a:lvl2pPr>
      <a:lvl3pPr marL="2025015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835275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3190" kern="1200">
          <a:solidFill>
            <a:schemeClr val="tx1"/>
          </a:solidFill>
          <a:latin typeface="+mn-lt"/>
          <a:ea typeface="+mn-ea"/>
          <a:cs typeface="+mn-cs"/>
        </a:defRPr>
      </a:lvl4pPr>
      <a:lvl5pPr marL="3644900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3190" kern="1200">
          <a:solidFill>
            <a:schemeClr val="tx1"/>
          </a:solidFill>
          <a:latin typeface="+mn-lt"/>
          <a:ea typeface="+mn-ea"/>
          <a:cs typeface="+mn-cs"/>
        </a:defRPr>
      </a:lvl5pPr>
      <a:lvl6pPr marL="4455160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3190" kern="1200">
          <a:solidFill>
            <a:schemeClr val="tx1"/>
          </a:solidFill>
          <a:latin typeface="+mn-lt"/>
          <a:ea typeface="+mn-ea"/>
          <a:cs typeface="+mn-cs"/>
        </a:defRPr>
      </a:lvl6pPr>
      <a:lvl7pPr marL="5265420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3190" kern="1200">
          <a:solidFill>
            <a:schemeClr val="tx1"/>
          </a:solidFill>
          <a:latin typeface="+mn-lt"/>
          <a:ea typeface="+mn-ea"/>
          <a:cs typeface="+mn-cs"/>
        </a:defRPr>
      </a:lvl7pPr>
      <a:lvl8pPr marL="6075045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3190" kern="1200">
          <a:solidFill>
            <a:schemeClr val="tx1"/>
          </a:solidFill>
          <a:latin typeface="+mn-lt"/>
          <a:ea typeface="+mn-ea"/>
          <a:cs typeface="+mn-cs"/>
        </a:defRPr>
      </a:lvl8pPr>
      <a:lvl9pPr marL="6885305" indent="-405130" algn="l" defTabSz="1619885" rtl="0" eaLnBrk="1" latinLnBrk="0" hangingPunct="1">
        <a:lnSpc>
          <a:spcPct val="90000"/>
        </a:lnSpc>
        <a:spcBef>
          <a:spcPts val="885"/>
        </a:spcBef>
        <a:buFont typeface="Arial" panose="020B0604020202020204" pitchFamily="34" charset="0"/>
        <a:buChar char="•"/>
        <a:defRPr sz="31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1pPr>
      <a:lvl2pPr marL="810260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2pPr>
      <a:lvl3pPr marL="1619885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3pPr>
      <a:lvl4pPr marL="2430145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4pPr>
      <a:lvl5pPr marL="3239770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5pPr>
      <a:lvl6pPr marL="4050030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6pPr>
      <a:lvl7pPr marL="4860290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7pPr>
      <a:lvl8pPr marL="5669915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5" algn="l" defTabSz="1619885" rtl="0" eaLnBrk="1" latinLnBrk="0" hangingPunct="1">
        <a:defRPr sz="31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jpeg"/><Relationship Id="rId10" Type="http://schemas.openxmlformats.org/officeDocument/2006/relationships/image" Target="../media/image5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4" name="组合 473"/>
          <p:cNvGrpSpPr/>
          <p:nvPr/>
        </p:nvGrpSpPr>
        <p:grpSpPr>
          <a:xfrm>
            <a:off x="440210" y="993961"/>
            <a:ext cx="15320017" cy="19380145"/>
            <a:chOff x="-991665" y="-7928587"/>
            <a:chExt cx="15320017" cy="19380145"/>
          </a:xfrm>
        </p:grpSpPr>
        <p:pic>
          <p:nvPicPr>
            <p:cNvPr id="475" name="图片 474" descr="铅笔放在一起&#10;&#10;低可信度描述已自动生成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6" t="6022" r="6003"/>
            <a:stretch>
              <a:fillRect/>
            </a:stretch>
          </p:blipFill>
          <p:spPr>
            <a:xfrm>
              <a:off x="203200" y="-7126223"/>
              <a:ext cx="11250810" cy="2957990"/>
            </a:xfrm>
            <a:prstGeom prst="rect">
              <a:avLst/>
            </a:prstGeom>
          </p:spPr>
        </p:pic>
        <p:sp>
          <p:nvSpPr>
            <p:cNvPr id="476" name="文本框 475"/>
            <p:cNvSpPr txBox="1"/>
            <p:nvPr/>
          </p:nvSpPr>
          <p:spPr>
            <a:xfrm rot="16200000">
              <a:off x="-1496291" y="-4223323"/>
              <a:ext cx="266718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se2-CIT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7" name="文本框 476"/>
            <p:cNvSpPr txBox="1"/>
            <p:nvPr/>
          </p:nvSpPr>
          <p:spPr>
            <a:xfrm>
              <a:off x="4756359" y="-7668763"/>
              <a:ext cx="266718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8" name="文本框 477"/>
            <p:cNvSpPr txBox="1"/>
            <p:nvPr/>
          </p:nvSpPr>
          <p:spPr>
            <a:xfrm>
              <a:off x="4756358" y="-4166568"/>
              <a:ext cx="266718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79" name="图片 478" descr="图表, 条形图&#10;&#10;描述已自动生成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7" t="7933" r="5747"/>
            <a:stretch>
              <a:fillRect/>
            </a:stretch>
          </p:blipFill>
          <p:spPr>
            <a:xfrm>
              <a:off x="203199" y="-3566993"/>
              <a:ext cx="11281999" cy="2897867"/>
            </a:xfrm>
            <a:prstGeom prst="rect">
              <a:avLst/>
            </a:prstGeom>
          </p:spPr>
        </p:pic>
        <p:sp>
          <p:nvSpPr>
            <p:cNvPr id="480" name="文本框 479"/>
            <p:cNvSpPr txBox="1"/>
            <p:nvPr/>
          </p:nvSpPr>
          <p:spPr>
            <a:xfrm rot="16200000">
              <a:off x="-1496291" y="3077548"/>
              <a:ext cx="266718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se4-CIT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81" name="图片 480" descr="图表, 条形图&#10;&#10;描述已自动生成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6" t="8336" r="5221" b="1365"/>
            <a:stretch>
              <a:fillRect/>
            </a:stretch>
          </p:blipFill>
          <p:spPr>
            <a:xfrm>
              <a:off x="203199" y="496261"/>
              <a:ext cx="11352308" cy="2569510"/>
            </a:xfrm>
            <a:prstGeom prst="rect">
              <a:avLst/>
            </a:prstGeom>
          </p:spPr>
        </p:pic>
        <p:pic>
          <p:nvPicPr>
            <p:cNvPr id="482" name="图片 481" descr="图表, 条形图&#10;&#10;描述已自动生成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7" t="6267" r="5220"/>
            <a:stretch>
              <a:fillRect/>
            </a:stretch>
          </p:blipFill>
          <p:spPr>
            <a:xfrm>
              <a:off x="169183" y="3888345"/>
              <a:ext cx="11386324" cy="2667188"/>
            </a:xfrm>
            <a:prstGeom prst="rect">
              <a:avLst/>
            </a:prstGeom>
          </p:spPr>
        </p:pic>
        <p:sp>
          <p:nvSpPr>
            <p:cNvPr id="483" name="文本框 482"/>
            <p:cNvSpPr txBox="1"/>
            <p:nvPr/>
          </p:nvSpPr>
          <p:spPr>
            <a:xfrm>
              <a:off x="4756360" y="-195311"/>
              <a:ext cx="266718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4" name="文本框 483"/>
            <p:cNvSpPr txBox="1"/>
            <p:nvPr/>
          </p:nvSpPr>
          <p:spPr>
            <a:xfrm>
              <a:off x="4756359" y="3222774"/>
              <a:ext cx="266718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5" name="文本框 484"/>
            <p:cNvSpPr txBox="1"/>
            <p:nvPr/>
          </p:nvSpPr>
          <p:spPr>
            <a:xfrm>
              <a:off x="706802" y="-7349611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6" name="文本框 485"/>
            <p:cNvSpPr txBox="1"/>
            <p:nvPr/>
          </p:nvSpPr>
          <p:spPr>
            <a:xfrm>
              <a:off x="2678205" y="-7349611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7" name="文本框 486"/>
            <p:cNvSpPr txBox="1"/>
            <p:nvPr/>
          </p:nvSpPr>
          <p:spPr>
            <a:xfrm>
              <a:off x="4591759" y="-7349611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8" name="文本框 487"/>
            <p:cNvSpPr txBox="1"/>
            <p:nvPr/>
          </p:nvSpPr>
          <p:spPr>
            <a:xfrm>
              <a:off x="6398779" y="-7349611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9" name="文本框 488"/>
            <p:cNvSpPr txBox="1"/>
            <p:nvPr/>
          </p:nvSpPr>
          <p:spPr>
            <a:xfrm>
              <a:off x="8333754" y="-7349611"/>
              <a:ext cx="1154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OSCTTM</a:t>
              </a:r>
              <a:r>
                <a:rPr kumimoji="0" lang="en-US" altLang="zh-CN" sz="1400" b="0" i="0" u="none" strike="noStrike" kern="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400" b="0" i="0" u="none" strike="noStrike" kern="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0" name="文本框 489"/>
            <p:cNvSpPr txBox="1"/>
            <p:nvPr/>
          </p:nvSpPr>
          <p:spPr>
            <a:xfrm>
              <a:off x="9985667" y="-7349611"/>
              <a:ext cx="14683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ing score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1" name="文本框 490"/>
            <p:cNvSpPr txBox="1"/>
            <p:nvPr/>
          </p:nvSpPr>
          <p:spPr>
            <a:xfrm>
              <a:off x="706802" y="-383409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2" name="文本框 491"/>
            <p:cNvSpPr txBox="1"/>
            <p:nvPr/>
          </p:nvSpPr>
          <p:spPr>
            <a:xfrm>
              <a:off x="2678205" y="-383409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3" name="文本框 492"/>
            <p:cNvSpPr txBox="1"/>
            <p:nvPr/>
          </p:nvSpPr>
          <p:spPr>
            <a:xfrm>
              <a:off x="4591759" y="-383409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4" name="文本框 493"/>
            <p:cNvSpPr txBox="1"/>
            <p:nvPr/>
          </p:nvSpPr>
          <p:spPr>
            <a:xfrm>
              <a:off x="6398779" y="-383409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5" name="文本框 494"/>
            <p:cNvSpPr txBox="1"/>
            <p:nvPr/>
          </p:nvSpPr>
          <p:spPr>
            <a:xfrm>
              <a:off x="9985667" y="-3834097"/>
              <a:ext cx="14683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ing score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96" name="文本框 495"/>
                <p:cNvSpPr txBox="1"/>
                <p:nvPr/>
              </p:nvSpPr>
              <p:spPr>
                <a:xfrm>
                  <a:off x="11364642" y="-6421405"/>
                  <a:ext cx="107522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kumimoji="0" lang="en-US" altLang="zh-CN" sz="1400" b="0" i="1" u="none" strike="noStrike" kern="0" cap="none" spc="0" normalizeH="0" baseline="0" noProof="0" dirty="0" smtClean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  <m:t>𝑑</m:t>
                        </m:r>
                      </m:oMath>
                    </m:oMathPara>
                  </a14:m>
                  <a:endParaRPr kumimoji="0" lang="zh-CN" alt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106" name="文本框 10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364642" y="-6421405"/>
                  <a:ext cx="1075226" cy="307777"/>
                </a:xfrm>
                <a:prstGeom prst="rect">
                  <a:avLst/>
                </a:prstGeom>
                <a:blipFill rotWithShape="1">
                  <a:blip r:embed="rId6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497" name="矩形 496"/>
            <p:cNvSpPr/>
            <p:nvPr/>
          </p:nvSpPr>
          <p:spPr>
            <a:xfrm>
              <a:off x="11745365" y="-6075734"/>
              <a:ext cx="216000" cy="10800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98" name="矩形 497"/>
            <p:cNvSpPr/>
            <p:nvPr/>
          </p:nvSpPr>
          <p:spPr>
            <a:xfrm>
              <a:off x="11745365" y="-5871948"/>
              <a:ext cx="216000" cy="108000"/>
            </a:xfrm>
            <a:prstGeom prst="rect">
              <a:avLst/>
            </a:prstGeom>
            <a:solidFill>
              <a:srgbClr val="E4832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99" name="矩形 498"/>
            <p:cNvSpPr/>
            <p:nvPr/>
          </p:nvSpPr>
          <p:spPr>
            <a:xfrm>
              <a:off x="11745365" y="-5668405"/>
              <a:ext cx="216000" cy="108000"/>
            </a:xfrm>
            <a:prstGeom prst="rect">
              <a:avLst/>
            </a:prstGeom>
            <a:solidFill>
              <a:srgbClr val="3A943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0" name="矩形 499"/>
            <p:cNvSpPr/>
            <p:nvPr/>
          </p:nvSpPr>
          <p:spPr>
            <a:xfrm>
              <a:off x="11748305" y="-5464862"/>
              <a:ext cx="216000" cy="108000"/>
            </a:xfrm>
            <a:prstGeom prst="rect">
              <a:avLst/>
            </a:prstGeom>
            <a:solidFill>
              <a:srgbClr val="C13D3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1" name="文本框 500"/>
            <p:cNvSpPr txBox="1"/>
            <p:nvPr/>
          </p:nvSpPr>
          <p:spPr>
            <a:xfrm>
              <a:off x="11951027" y="-6188004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2" name="文本框 501"/>
            <p:cNvSpPr txBox="1"/>
            <p:nvPr/>
          </p:nvSpPr>
          <p:spPr>
            <a:xfrm>
              <a:off x="11951027" y="-5971836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3" name="文本框 502"/>
            <p:cNvSpPr txBox="1"/>
            <p:nvPr/>
          </p:nvSpPr>
          <p:spPr>
            <a:xfrm>
              <a:off x="11939597" y="-5768537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4" name="文本框 503"/>
            <p:cNvSpPr txBox="1"/>
            <p:nvPr/>
          </p:nvSpPr>
          <p:spPr>
            <a:xfrm>
              <a:off x="11951027" y="-5562699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5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05" name="文本框 504"/>
                <p:cNvSpPr txBox="1"/>
                <p:nvPr/>
              </p:nvSpPr>
              <p:spPr>
                <a:xfrm>
                  <a:off x="11454009" y="-2829950"/>
                  <a:ext cx="63041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kumimoji="0" lang="en-US" altLang="zh-CN" sz="1400" b="0" i="1" u="none" strike="noStrike" kern="0" cap="none" spc="0" normalizeH="0" baseline="0" noProof="0" dirty="0" smtClean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  <m:t>𝑑</m:t>
                        </m:r>
                      </m:oMath>
                    </m:oMathPara>
                  </a14:m>
                  <a:endParaRPr kumimoji="0" lang="zh-CN" alt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126" name="文本框 12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454009" y="-2829950"/>
                  <a:ext cx="630416" cy="307777"/>
                </a:xfrm>
                <a:prstGeom prst="rect">
                  <a:avLst/>
                </a:prstGeom>
                <a:blipFill rotWithShape="1">
                  <a:blip r:embed="rId7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506" name="矩形 505"/>
            <p:cNvSpPr/>
            <p:nvPr/>
          </p:nvSpPr>
          <p:spPr>
            <a:xfrm>
              <a:off x="11634425" y="-2484279"/>
              <a:ext cx="216000" cy="10800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7" name="矩形 506"/>
            <p:cNvSpPr/>
            <p:nvPr/>
          </p:nvSpPr>
          <p:spPr>
            <a:xfrm>
              <a:off x="11634425" y="-2280493"/>
              <a:ext cx="216000" cy="108000"/>
            </a:xfrm>
            <a:prstGeom prst="rect">
              <a:avLst/>
            </a:prstGeom>
            <a:solidFill>
              <a:srgbClr val="E4832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8" name="矩形 507"/>
            <p:cNvSpPr/>
            <p:nvPr/>
          </p:nvSpPr>
          <p:spPr>
            <a:xfrm>
              <a:off x="11634425" y="-2076950"/>
              <a:ext cx="216000" cy="108000"/>
            </a:xfrm>
            <a:prstGeom prst="rect">
              <a:avLst/>
            </a:prstGeom>
            <a:solidFill>
              <a:srgbClr val="3A943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9" name="矩形 508"/>
            <p:cNvSpPr/>
            <p:nvPr/>
          </p:nvSpPr>
          <p:spPr>
            <a:xfrm>
              <a:off x="11637365" y="-1873407"/>
              <a:ext cx="216000" cy="108000"/>
            </a:xfrm>
            <a:prstGeom prst="rect">
              <a:avLst/>
            </a:prstGeom>
            <a:solidFill>
              <a:srgbClr val="C13D3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10" name="文本框 509"/>
            <p:cNvSpPr txBox="1"/>
            <p:nvPr/>
          </p:nvSpPr>
          <p:spPr>
            <a:xfrm>
              <a:off x="11840087" y="-2596549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1" name="文本框 510"/>
            <p:cNvSpPr txBox="1"/>
            <p:nvPr/>
          </p:nvSpPr>
          <p:spPr>
            <a:xfrm>
              <a:off x="11840087" y="-2380381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2" name="文本框 511"/>
            <p:cNvSpPr txBox="1"/>
            <p:nvPr/>
          </p:nvSpPr>
          <p:spPr>
            <a:xfrm>
              <a:off x="11828657" y="-2177082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3" name="文本框 512"/>
            <p:cNvSpPr txBox="1"/>
            <p:nvPr/>
          </p:nvSpPr>
          <p:spPr>
            <a:xfrm>
              <a:off x="11840087" y="-1971244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5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4" name="文本框 513"/>
            <p:cNvSpPr txBox="1"/>
            <p:nvPr/>
          </p:nvSpPr>
          <p:spPr>
            <a:xfrm>
              <a:off x="1211734" y="199943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5" name="文本框 514"/>
            <p:cNvSpPr txBox="1"/>
            <p:nvPr/>
          </p:nvSpPr>
          <p:spPr>
            <a:xfrm>
              <a:off x="4048936" y="199943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6" name="文本框 515"/>
            <p:cNvSpPr txBox="1"/>
            <p:nvPr/>
          </p:nvSpPr>
          <p:spPr>
            <a:xfrm>
              <a:off x="6933168" y="199943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7" name="文本框 516"/>
            <p:cNvSpPr txBox="1"/>
            <p:nvPr/>
          </p:nvSpPr>
          <p:spPr>
            <a:xfrm>
              <a:off x="9644612" y="199943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18" name="文本框 517"/>
                <p:cNvSpPr txBox="1"/>
                <p:nvPr/>
              </p:nvSpPr>
              <p:spPr>
                <a:xfrm>
                  <a:off x="11486011" y="987466"/>
                  <a:ext cx="63041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kumimoji="0" lang="en-US" altLang="zh-CN" sz="1400" b="0" i="1" u="none" strike="noStrike" kern="0" cap="none" spc="0" normalizeH="0" baseline="0" noProof="0" dirty="0" smtClean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  <m:t>𝑑</m:t>
                        </m:r>
                      </m:oMath>
                    </m:oMathPara>
                  </a14:m>
                  <a:endParaRPr kumimoji="0" lang="zh-CN" alt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147" name="文本框 146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486011" y="987466"/>
                  <a:ext cx="630416" cy="307777"/>
                </a:xfrm>
                <a:prstGeom prst="rect">
                  <a:avLst/>
                </a:prstGeom>
                <a:blipFill rotWithShape="1">
                  <a:blip r:embed="rId8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519" name="矩形 518"/>
            <p:cNvSpPr/>
            <p:nvPr/>
          </p:nvSpPr>
          <p:spPr>
            <a:xfrm>
              <a:off x="11666427" y="1333137"/>
              <a:ext cx="216000" cy="10800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20" name="矩形 519"/>
            <p:cNvSpPr/>
            <p:nvPr/>
          </p:nvSpPr>
          <p:spPr>
            <a:xfrm>
              <a:off x="11666427" y="1536923"/>
              <a:ext cx="216000" cy="108000"/>
            </a:xfrm>
            <a:prstGeom prst="rect">
              <a:avLst/>
            </a:prstGeom>
            <a:solidFill>
              <a:srgbClr val="E4832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21" name="矩形 520"/>
            <p:cNvSpPr/>
            <p:nvPr/>
          </p:nvSpPr>
          <p:spPr>
            <a:xfrm>
              <a:off x="11666427" y="1740466"/>
              <a:ext cx="216000" cy="108000"/>
            </a:xfrm>
            <a:prstGeom prst="rect">
              <a:avLst/>
            </a:prstGeom>
            <a:solidFill>
              <a:srgbClr val="3A943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22" name="矩形 521"/>
            <p:cNvSpPr/>
            <p:nvPr/>
          </p:nvSpPr>
          <p:spPr>
            <a:xfrm>
              <a:off x="11669367" y="1944009"/>
              <a:ext cx="216000" cy="108000"/>
            </a:xfrm>
            <a:prstGeom prst="rect">
              <a:avLst/>
            </a:prstGeom>
            <a:solidFill>
              <a:srgbClr val="C13D3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23" name="文本框 522"/>
            <p:cNvSpPr txBox="1"/>
            <p:nvPr/>
          </p:nvSpPr>
          <p:spPr>
            <a:xfrm>
              <a:off x="11872089" y="1220867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" name="文本框 523"/>
            <p:cNvSpPr txBox="1"/>
            <p:nvPr/>
          </p:nvSpPr>
          <p:spPr>
            <a:xfrm>
              <a:off x="11872089" y="1437035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" name="文本框 524"/>
            <p:cNvSpPr txBox="1"/>
            <p:nvPr/>
          </p:nvSpPr>
          <p:spPr>
            <a:xfrm>
              <a:off x="11860659" y="1640334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" name="文本框 525"/>
            <p:cNvSpPr txBox="1"/>
            <p:nvPr/>
          </p:nvSpPr>
          <p:spPr>
            <a:xfrm>
              <a:off x="11872089" y="1846172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5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7" name="文本框 526"/>
            <p:cNvSpPr txBox="1"/>
            <p:nvPr/>
          </p:nvSpPr>
          <p:spPr>
            <a:xfrm>
              <a:off x="1211734" y="368728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" name="文本框 527"/>
            <p:cNvSpPr txBox="1"/>
            <p:nvPr/>
          </p:nvSpPr>
          <p:spPr>
            <a:xfrm>
              <a:off x="4048936" y="368728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 </a:t>
              </a: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" name="文本框 528"/>
            <p:cNvSpPr txBox="1"/>
            <p:nvPr/>
          </p:nvSpPr>
          <p:spPr>
            <a:xfrm>
              <a:off x="6933168" y="368728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0" name="文本框 529"/>
            <p:cNvSpPr txBox="1"/>
            <p:nvPr/>
          </p:nvSpPr>
          <p:spPr>
            <a:xfrm>
              <a:off x="9644612" y="3687287"/>
              <a:ext cx="1075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31" name="文本框 530"/>
                <p:cNvSpPr txBox="1"/>
                <p:nvPr/>
              </p:nvSpPr>
              <p:spPr>
                <a:xfrm>
                  <a:off x="11460920" y="4462371"/>
                  <a:ext cx="63041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kumimoji="0" lang="en-US" altLang="zh-CN" sz="1400" b="0" i="1" u="none" strike="noStrike" kern="0" cap="none" spc="0" normalizeH="0" baseline="0" noProof="0" dirty="0" smtClean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  <m:t>𝑑</m:t>
                        </m:r>
                      </m:oMath>
                    </m:oMathPara>
                  </a14:m>
                  <a:endParaRPr kumimoji="0" lang="zh-CN" altLang="en-US" sz="1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160" name="文本框 159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460920" y="4462371"/>
                  <a:ext cx="630416" cy="307777"/>
                </a:xfrm>
                <a:prstGeom prst="rect">
                  <a:avLst/>
                </a:prstGeom>
                <a:blipFill rotWithShape="1">
                  <a:blip r:embed="rId9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532" name="矩形 531"/>
            <p:cNvSpPr/>
            <p:nvPr/>
          </p:nvSpPr>
          <p:spPr>
            <a:xfrm>
              <a:off x="11641336" y="4808042"/>
              <a:ext cx="216000" cy="10800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33" name="矩形 532"/>
            <p:cNvSpPr/>
            <p:nvPr/>
          </p:nvSpPr>
          <p:spPr>
            <a:xfrm>
              <a:off x="11641336" y="5011828"/>
              <a:ext cx="216000" cy="108000"/>
            </a:xfrm>
            <a:prstGeom prst="rect">
              <a:avLst/>
            </a:prstGeom>
            <a:solidFill>
              <a:srgbClr val="E4832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34" name="矩形 533"/>
            <p:cNvSpPr/>
            <p:nvPr/>
          </p:nvSpPr>
          <p:spPr>
            <a:xfrm>
              <a:off x="11641336" y="5215371"/>
              <a:ext cx="216000" cy="108000"/>
            </a:xfrm>
            <a:prstGeom prst="rect">
              <a:avLst/>
            </a:prstGeom>
            <a:solidFill>
              <a:srgbClr val="3A943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35" name="矩形 534"/>
            <p:cNvSpPr/>
            <p:nvPr/>
          </p:nvSpPr>
          <p:spPr>
            <a:xfrm>
              <a:off x="11644276" y="5418914"/>
              <a:ext cx="216000" cy="108000"/>
            </a:xfrm>
            <a:prstGeom prst="rect">
              <a:avLst/>
            </a:prstGeom>
            <a:solidFill>
              <a:srgbClr val="C13D3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36" name="文本框 535"/>
            <p:cNvSpPr txBox="1"/>
            <p:nvPr/>
          </p:nvSpPr>
          <p:spPr>
            <a:xfrm>
              <a:off x="11846998" y="4695772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7" name="文本框 536"/>
            <p:cNvSpPr txBox="1"/>
            <p:nvPr/>
          </p:nvSpPr>
          <p:spPr>
            <a:xfrm>
              <a:off x="11846998" y="4911940"/>
              <a:ext cx="3822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8" name="文本框 537"/>
            <p:cNvSpPr txBox="1"/>
            <p:nvPr/>
          </p:nvSpPr>
          <p:spPr>
            <a:xfrm>
              <a:off x="11835568" y="5115239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8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9" name="文本框 538"/>
            <p:cNvSpPr txBox="1"/>
            <p:nvPr/>
          </p:nvSpPr>
          <p:spPr>
            <a:xfrm>
              <a:off x="11846998" y="5321077"/>
              <a:ext cx="4819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56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40" name="图片 539" descr="图表, 折线图&#10;&#10;描述已自动生成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1" r="22513" b="16112"/>
            <a:stretch>
              <a:fillRect/>
            </a:stretch>
          </p:blipFill>
          <p:spPr>
            <a:xfrm>
              <a:off x="8505576" y="7632905"/>
              <a:ext cx="3453607" cy="3109227"/>
            </a:xfrm>
            <a:prstGeom prst="rect">
              <a:avLst/>
            </a:prstGeom>
          </p:spPr>
        </p:pic>
        <p:sp>
          <p:nvSpPr>
            <p:cNvPr id="541" name="文本框 540"/>
            <p:cNvSpPr txBox="1"/>
            <p:nvPr/>
          </p:nvSpPr>
          <p:spPr>
            <a:xfrm rot="16200000">
              <a:off x="6308023" y="9167524"/>
              <a:ext cx="4029286" cy="3987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unning time (s)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2" name="矩形 541"/>
            <p:cNvSpPr/>
            <p:nvPr/>
          </p:nvSpPr>
          <p:spPr>
            <a:xfrm>
              <a:off x="12094602" y="8820049"/>
              <a:ext cx="216000" cy="10800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3" name="矩形 542"/>
            <p:cNvSpPr/>
            <p:nvPr/>
          </p:nvSpPr>
          <p:spPr>
            <a:xfrm>
              <a:off x="12094602" y="9023835"/>
              <a:ext cx="216000" cy="108000"/>
            </a:xfrm>
            <a:prstGeom prst="rect">
              <a:avLst/>
            </a:prstGeom>
            <a:solidFill>
              <a:srgbClr val="E4832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4" name="矩形 543"/>
            <p:cNvSpPr/>
            <p:nvPr/>
          </p:nvSpPr>
          <p:spPr>
            <a:xfrm>
              <a:off x="12094602" y="9227378"/>
              <a:ext cx="216000" cy="108000"/>
            </a:xfrm>
            <a:prstGeom prst="rect">
              <a:avLst/>
            </a:prstGeom>
            <a:solidFill>
              <a:srgbClr val="3A943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5" name="矩形 544"/>
            <p:cNvSpPr/>
            <p:nvPr/>
          </p:nvSpPr>
          <p:spPr>
            <a:xfrm>
              <a:off x="12094602" y="9430921"/>
              <a:ext cx="216000" cy="108000"/>
            </a:xfrm>
            <a:prstGeom prst="rect">
              <a:avLst/>
            </a:prstGeom>
            <a:solidFill>
              <a:srgbClr val="C13D3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6" name="文本框 545"/>
            <p:cNvSpPr txBox="1"/>
            <p:nvPr/>
          </p:nvSpPr>
          <p:spPr>
            <a:xfrm>
              <a:off x="12300263" y="8707779"/>
              <a:ext cx="8517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7" name="文本框 546"/>
            <p:cNvSpPr txBox="1"/>
            <p:nvPr/>
          </p:nvSpPr>
          <p:spPr>
            <a:xfrm>
              <a:off x="12300263" y="8923947"/>
              <a:ext cx="11802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8" name="文本框 547"/>
            <p:cNvSpPr txBox="1"/>
            <p:nvPr/>
          </p:nvSpPr>
          <p:spPr>
            <a:xfrm>
              <a:off x="12288834" y="9127246"/>
              <a:ext cx="8365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9" name="文本框 548"/>
            <p:cNvSpPr txBox="1"/>
            <p:nvPr/>
          </p:nvSpPr>
          <p:spPr>
            <a:xfrm>
              <a:off x="12300264" y="9333084"/>
              <a:ext cx="9670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0" name="矩形 549"/>
            <p:cNvSpPr/>
            <p:nvPr/>
          </p:nvSpPr>
          <p:spPr>
            <a:xfrm>
              <a:off x="12094602" y="9635780"/>
              <a:ext cx="216000" cy="108000"/>
            </a:xfrm>
            <a:prstGeom prst="rect">
              <a:avLst/>
            </a:prstGeom>
            <a:solidFill>
              <a:srgbClr val="9268B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51" name="文本框 550"/>
            <p:cNvSpPr txBox="1"/>
            <p:nvPr/>
          </p:nvSpPr>
          <p:spPr>
            <a:xfrm>
              <a:off x="12300773" y="9537943"/>
              <a:ext cx="9670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2" name="矩形 551"/>
            <p:cNvSpPr/>
            <p:nvPr/>
          </p:nvSpPr>
          <p:spPr>
            <a:xfrm>
              <a:off x="12094602" y="9834241"/>
              <a:ext cx="216000" cy="108000"/>
            </a:xfrm>
            <a:prstGeom prst="rect">
              <a:avLst/>
            </a:prstGeom>
            <a:solidFill>
              <a:srgbClr val="9054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53" name="文本框 552"/>
            <p:cNvSpPr txBox="1"/>
            <p:nvPr/>
          </p:nvSpPr>
          <p:spPr>
            <a:xfrm>
              <a:off x="12310602" y="9736404"/>
              <a:ext cx="20177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 (align + spec)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4" name="文本框 553"/>
            <p:cNvSpPr txBox="1"/>
            <p:nvPr/>
          </p:nvSpPr>
          <p:spPr>
            <a:xfrm>
              <a:off x="12011053" y="8491611"/>
              <a:ext cx="8517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ethod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5" name="文本框 554"/>
            <p:cNvSpPr txBox="1"/>
            <p:nvPr/>
          </p:nvSpPr>
          <p:spPr>
            <a:xfrm>
              <a:off x="9326420" y="11113004"/>
              <a:ext cx="20382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umber of cells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6" name="文本框 555"/>
            <p:cNvSpPr txBox="1"/>
            <p:nvPr/>
          </p:nvSpPr>
          <p:spPr>
            <a:xfrm>
              <a:off x="-781859" y="-7928587"/>
              <a:ext cx="1257824" cy="7694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4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7" name="文本框 556"/>
            <p:cNvSpPr txBox="1"/>
            <p:nvPr/>
          </p:nvSpPr>
          <p:spPr>
            <a:xfrm>
              <a:off x="-791610" y="-669126"/>
              <a:ext cx="1257824" cy="7694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4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8" name="文本框 557"/>
            <p:cNvSpPr txBox="1"/>
            <p:nvPr/>
          </p:nvSpPr>
          <p:spPr>
            <a:xfrm>
              <a:off x="-991665" y="6930013"/>
              <a:ext cx="1257824" cy="7694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4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0" lang="zh-CN" altLang="en-US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9" name="文本框 558"/>
            <p:cNvSpPr txBox="1"/>
            <p:nvPr/>
          </p:nvSpPr>
          <p:spPr>
            <a:xfrm>
              <a:off x="8333914" y="-3829678"/>
              <a:ext cx="1154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OSCTTM</a:t>
              </a:r>
              <a:r>
                <a:rPr kumimoji="0" lang="en-US" altLang="zh-CN" sz="1400" b="0" i="0" u="none" strike="noStrike" kern="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400" b="0" i="0" u="none" strike="noStrike" kern="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60" name="组合 559"/>
            <p:cNvGrpSpPr/>
            <p:nvPr/>
          </p:nvGrpSpPr>
          <p:grpSpPr>
            <a:xfrm>
              <a:off x="-89551" y="7327133"/>
              <a:ext cx="7731434" cy="3905824"/>
              <a:chOff x="96916" y="7211783"/>
              <a:chExt cx="7731434" cy="3905824"/>
            </a:xfrm>
          </p:grpSpPr>
          <p:pic>
            <p:nvPicPr>
              <p:cNvPr id="562" name="图片 561" descr="图表, 条形图&#10;&#10;描述已自动生成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24" b="5874"/>
              <a:stretch>
                <a:fillRect/>
              </a:stretch>
            </p:blipFill>
            <p:spPr>
              <a:xfrm>
                <a:off x="4166994" y="7656800"/>
                <a:ext cx="3661356" cy="3126367"/>
              </a:xfrm>
              <a:prstGeom prst="rect">
                <a:avLst/>
              </a:prstGeom>
            </p:spPr>
          </p:pic>
          <p:pic>
            <p:nvPicPr>
              <p:cNvPr id="563" name="图片 562" descr="图表, 条形图&#10;&#10;描述已自动生成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05" b="5956"/>
              <a:stretch>
                <a:fillRect/>
              </a:stretch>
            </p:blipFill>
            <p:spPr>
              <a:xfrm>
                <a:off x="96916" y="7648272"/>
                <a:ext cx="3654908" cy="3134028"/>
              </a:xfrm>
              <a:prstGeom prst="rect">
                <a:avLst/>
              </a:prstGeom>
            </p:spPr>
          </p:pic>
          <p:sp>
            <p:nvSpPr>
              <p:cNvPr id="564" name="文本框 563"/>
              <p:cNvSpPr txBox="1"/>
              <p:nvPr/>
            </p:nvSpPr>
            <p:spPr>
              <a:xfrm>
                <a:off x="709454" y="7211783"/>
                <a:ext cx="266718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ase2-CITE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5" name="文本框 564"/>
              <p:cNvSpPr txBox="1"/>
              <p:nvPr/>
            </p:nvSpPr>
            <p:spPr>
              <a:xfrm>
                <a:off x="4803594" y="7211783"/>
                <a:ext cx="266718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ase4-CITE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6" name="文本框 565"/>
              <p:cNvSpPr txBox="1"/>
              <p:nvPr/>
            </p:nvSpPr>
            <p:spPr>
              <a:xfrm>
                <a:off x="1307944" y="10809830"/>
                <a:ext cx="10752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etric</a:t>
                </a:r>
                <a:endParaRPr kumimoji="0" lang="zh-CN" alt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7" name="文本框 566"/>
              <p:cNvSpPr txBox="1"/>
              <p:nvPr/>
            </p:nvSpPr>
            <p:spPr>
              <a:xfrm>
                <a:off x="5341740" y="10809830"/>
                <a:ext cx="10752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4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etric</a:t>
                </a:r>
                <a:endParaRPr kumimoji="0" lang="zh-CN" alt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1" name="文本框 560"/>
            <p:cNvSpPr txBox="1"/>
            <p:nvPr/>
          </p:nvSpPr>
          <p:spPr>
            <a:xfrm>
              <a:off x="7423545" y="7002731"/>
              <a:ext cx="1257824" cy="76944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4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0" lang="zh-CN" altLang="en-US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B291B738-C29C-20C7-3A70-C815F1567349}"/>
              </a:ext>
            </a:extLst>
          </p:cNvPr>
          <p:cNvSpPr txBox="1"/>
          <p:nvPr/>
        </p:nvSpPr>
        <p:spPr>
          <a:xfrm rot="18000000">
            <a:off x="10165080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AEBFB9A-EE57-FE6E-9659-9A73AF2C85F3}"/>
              </a:ext>
            </a:extLst>
          </p:cNvPr>
          <p:cNvSpPr txBox="1"/>
          <p:nvPr/>
        </p:nvSpPr>
        <p:spPr>
          <a:xfrm rot="18000000">
            <a:off x="10511415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7F7F8683-0F35-9733-3358-AD2CB613195D}"/>
              </a:ext>
            </a:extLst>
          </p:cNvPr>
          <p:cNvSpPr txBox="1"/>
          <p:nvPr/>
        </p:nvSpPr>
        <p:spPr>
          <a:xfrm rot="18000000">
            <a:off x="10857748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6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EE2479E-A716-E389-C5AD-5E4B83BA5699}"/>
              </a:ext>
            </a:extLst>
          </p:cNvPr>
          <p:cNvSpPr txBox="1"/>
          <p:nvPr/>
        </p:nvSpPr>
        <p:spPr>
          <a:xfrm rot="18000000">
            <a:off x="11204081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8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4BDBA9D-CBA3-FDD3-515C-728980ECE017}"/>
              </a:ext>
            </a:extLst>
          </p:cNvPr>
          <p:cNvSpPr txBox="1"/>
          <p:nvPr/>
        </p:nvSpPr>
        <p:spPr>
          <a:xfrm rot="18000000">
            <a:off x="11550415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16F2278-692F-31E4-7557-E2FEF56BF347}"/>
              </a:ext>
            </a:extLst>
          </p:cNvPr>
          <p:cNvSpPr txBox="1"/>
          <p:nvPr/>
        </p:nvSpPr>
        <p:spPr>
          <a:xfrm rot="18000000">
            <a:off x="11941576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2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61C8D6E-0AA4-6060-6A7C-75A8D5233412}"/>
              </a:ext>
            </a:extLst>
          </p:cNvPr>
          <p:cNvSpPr txBox="1"/>
          <p:nvPr/>
        </p:nvSpPr>
        <p:spPr>
          <a:xfrm rot="18000000">
            <a:off x="12287909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4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F4A4F12-3330-6A62-93AF-8CC58C778DB1}"/>
              </a:ext>
            </a:extLst>
          </p:cNvPr>
          <p:cNvSpPr txBox="1"/>
          <p:nvPr/>
        </p:nvSpPr>
        <p:spPr>
          <a:xfrm rot="18000000">
            <a:off x="12634243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60,0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0613822-8B1E-8967-6E2A-6C6098598EB7}"/>
              </a:ext>
            </a:extLst>
          </p:cNvPr>
          <p:cNvSpPr txBox="1"/>
          <p:nvPr/>
        </p:nvSpPr>
        <p:spPr>
          <a:xfrm rot="18000000">
            <a:off x="9818747" y="19926520"/>
            <a:ext cx="985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93</Words>
  <Application>Microsoft Office PowerPoint</Application>
  <PresentationFormat>自定义</PresentationFormat>
  <Paragraphs>7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mbria Math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4</cp:revision>
  <dcterms:created xsi:type="dcterms:W3CDTF">2024-12-11T02:44:00Z</dcterms:created>
  <dcterms:modified xsi:type="dcterms:W3CDTF">2025-06-27T08:22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0.6206</vt:lpwstr>
  </property>
</Properties>
</file>